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0" r:id="rId2"/>
    <p:sldId id="281" r:id="rId3"/>
    <p:sldId id="282" r:id="rId4"/>
    <p:sldId id="283" r:id="rId5"/>
    <p:sldId id="28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061" autoAdjust="0"/>
  </p:normalViewPr>
  <p:slideViewPr>
    <p:cSldViewPr snapToGrid="0">
      <p:cViewPr varScale="1">
        <p:scale>
          <a:sx n="93" d="100"/>
          <a:sy n="93" d="100"/>
        </p:scale>
        <p:origin x="302" y="8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09BBE-3F94-7DB9-051F-6A25415A17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D84E02-32E4-EE34-44A1-B780E10694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026211-B94B-7A03-7D7D-6CFB022D7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DDDFDC-F1FA-6BE9-B1D9-B788C90E6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E85EE2-D69A-41C4-A508-E36F1A9C4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595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80771-83AF-435D-240E-8C271EDED5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793FD0-9B83-E89D-A3AB-A11EEB6735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78D347-68A5-4B0C-75D8-C5F7115EF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3A95B3-81E2-65BA-6944-1583573A2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FA3C53-3649-40C0-42E9-C241F90E8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339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55B126-A6D8-5C05-C5B0-58272A8F4B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F4F66F-F77C-A7C8-AF93-1B91A1437C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59EE44-FD36-52F2-25D0-130502A40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52387F-88B7-0BE0-42A5-454FDEFBD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8FC3B1-C378-D550-78CD-8F078936B3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590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07C42F-A69F-DF8F-B5EF-259E64CAD3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9BF8CD-3045-6D13-A27E-E20FA5D091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BF09C9-E329-9A97-583E-96AD9219B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4883C5-AFEE-B7A1-CA0A-423234ED96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61DF69-43A3-CCED-6167-D1FFF146A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289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5671F-5E3A-D28B-B204-D7A2209855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834522-097B-3CE3-DC8D-E10A19A488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6EB214-7290-D581-E893-62B8832FA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2C4A92-2D05-4E97-291E-15D700F80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6845AD-4326-38F4-A23D-D28B28A5A3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280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C0383D-E0C7-B94F-826E-50DDA2B8CA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8254BE-7846-895F-735A-E147C38A94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346240-8D35-DE73-7967-39B6C017AA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131DDE-70EC-C0E4-5700-ADB04FAA5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1196A4-CFA7-F04F-75A3-576E7BE16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885AE7-2905-A117-128D-F5774106C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737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6F5A2-7694-7C09-BAA7-E3FF30B9AD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7CB90D-65CF-792B-C0EA-8C2020D296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0B5604-970A-1659-7D85-F97D5280BE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2B4D26-5FEF-0B13-32A6-D76F968907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40A835-4050-2486-CC7A-647C473670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A08CB2-2644-AFDB-A452-B914B8EAC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D055D9-BACB-A98C-0B5F-612BC5CAF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7D248F-4C48-5552-1FB5-EB9A608D5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242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F7AF3-8EFF-FB51-E989-A60BBD72B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8AF8C0-C6DF-FD07-8EE7-D320E143B4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00CDB5-3417-1611-5F1D-99AA60DC9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16C0D3-5B08-D6FA-28A8-88F479D7C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170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797CCF-B775-016E-2D30-432B6F6D2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FE44766-E2AE-B316-162C-2E6688CEB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590B9D-B9DB-F7C6-D3D1-A6E7D6C7B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008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DED230-E8FF-3FE2-E11C-284367C07D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1915BF-52E1-04BC-F672-5111968A18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DB14D5-A6E7-940C-38B4-70EBB30C84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6283F3-CCEC-ECD1-9661-EBFD26306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66B659-BB0C-4BE3-AB43-4E19A6946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ECCA12-21B1-0D5A-CF3F-2E6A06AD5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434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B34F5-6566-FBAD-E243-9AAFE568F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721F165-3C96-9BD3-7737-0821D44B1F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563189-ECA5-7F44-C4EF-A69132F0FA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C00FD8-6470-AC2E-ABBB-161D02D7D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111286-66B0-A9E5-E23E-F906B9D23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8BE44E-1175-4BC2-8DDF-1FCDB28FD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004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23B1FB2-6805-9237-7521-CB174C130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200F26-2205-081F-2C6C-5759049BF5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B172FA-9F37-AD40-3804-DDA6F35237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3D7E99-B567-4265-901C-ED80288908D8}" type="datetimeFigureOut">
              <a:rPr lang="en-US" smtClean="0"/>
              <a:t>9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2168FC-543B-ABD5-1DC4-EAB880DB1C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DDBCD6-868A-6A30-D241-AFF5042815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48899B1-E840-4250-8AEC-D9243D6D27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536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6B366D89-5683-1240-2080-75E7C6EE753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718773" y="-823811"/>
            <a:ext cx="4754454" cy="7252218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31613BB-2698-9156-B222-7C190782C162}"/>
              </a:ext>
            </a:extLst>
          </p:cNvPr>
          <p:cNvSpPr txBox="1"/>
          <p:nvPr/>
        </p:nvSpPr>
        <p:spPr>
          <a:xfrm>
            <a:off x="3047222" y="5409370"/>
            <a:ext cx="6097554" cy="6419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600" b="1" i="0" dirty="0">
                <a:solidFill>
                  <a:srgbClr val="0A0A0A"/>
                </a:solidFill>
                <a:effectLst/>
                <a:latin typeface="Google Sans"/>
              </a:rPr>
              <a:t>Supplementary Figure S1: High FLI1 immunohistochemical expression in normal tonsillar tissue (40x)</a:t>
            </a:r>
            <a:endParaRPr lang="en-SG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3990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92833" y="5380975"/>
            <a:ext cx="5393001" cy="6419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600" b="1" i="0" dirty="0">
                <a:solidFill>
                  <a:srgbClr val="0A0A0A"/>
                </a:solidFill>
                <a:effectLst/>
                <a:latin typeface="Google Sans"/>
              </a:rPr>
              <a:t>Supplementary Figure S2 </a:t>
            </a:r>
            <a:r>
              <a:rPr lang="en-US" sz="1600" b="1" dirty="0">
                <a:solidFill>
                  <a:srgbClr val="0A0A0A"/>
                </a:solidFill>
                <a:latin typeface="Google Sans"/>
              </a:rPr>
              <a:t>: H&amp;E staining of infiltrating duct carcinoma, Grade I (10x)  </a:t>
            </a:r>
            <a:endParaRPr lang="en-SG" sz="1600" b="1" dirty="0">
              <a:solidFill>
                <a:srgbClr val="0A0A0A"/>
              </a:solidFill>
              <a:latin typeface="Google Sans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459606" y="5380975"/>
            <a:ext cx="5331052" cy="6419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600" b="1" i="0" dirty="0">
                <a:solidFill>
                  <a:srgbClr val="0A0A0A"/>
                </a:solidFill>
                <a:effectLst/>
                <a:latin typeface="Google Sans"/>
              </a:rPr>
              <a:t>Supplementary Figure S3 </a:t>
            </a:r>
            <a:r>
              <a:rPr lang="en-US" sz="1600" b="1" dirty="0">
                <a:solidFill>
                  <a:srgbClr val="0A0A0A"/>
                </a:solidFill>
                <a:latin typeface="Google Sans"/>
              </a:rPr>
              <a:t>: Low FLI1 immunochemical expression in infiltrating duct carcinoma, Grade I (10x)</a:t>
            </a:r>
            <a:endParaRPr lang="en-SG" sz="1600" b="1" dirty="0">
              <a:solidFill>
                <a:srgbClr val="0A0A0A"/>
              </a:solidFill>
              <a:latin typeface="Google Sans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D547725-34DC-9F36-1DD1-D6AC95A9F51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92833" y="255186"/>
            <a:ext cx="5610091" cy="4975504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DFCFA55-46BA-6209-FDE8-B07E33A19DD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6319523" y="255186"/>
            <a:ext cx="5611219" cy="497550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5465188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object 4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22739" y="468923"/>
            <a:ext cx="5709138" cy="5029200"/>
          </a:xfrm>
          <a:prstGeom prst="rect">
            <a:avLst/>
          </a:prstGeom>
        </p:spPr>
      </p:pic>
      <p:pic>
        <p:nvPicPr>
          <p:cNvPr id="9" name="object 5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6494586" y="468922"/>
            <a:ext cx="5488744" cy="5029201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DFA15C1E-9F0F-B1A8-75E5-E8E3B256394B}"/>
              </a:ext>
            </a:extLst>
          </p:cNvPr>
          <p:cNvSpPr/>
          <p:nvPr/>
        </p:nvSpPr>
        <p:spPr>
          <a:xfrm>
            <a:off x="207248" y="5547972"/>
            <a:ext cx="5393001" cy="6419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600" b="1" i="0" dirty="0">
                <a:solidFill>
                  <a:srgbClr val="0A0A0A"/>
                </a:solidFill>
                <a:effectLst/>
                <a:latin typeface="Google Sans"/>
              </a:rPr>
              <a:t>Supplementary Figure S4 </a:t>
            </a:r>
            <a:r>
              <a:rPr lang="en-US" sz="1600" b="1" dirty="0">
                <a:solidFill>
                  <a:srgbClr val="0A0A0A"/>
                </a:solidFill>
                <a:latin typeface="Google Sans"/>
              </a:rPr>
              <a:t>: H&amp;E staining of infiltrating duct carcinoma, Grade II (10x)  </a:t>
            </a:r>
            <a:endParaRPr lang="en-SG" sz="1600" b="1" dirty="0">
              <a:solidFill>
                <a:srgbClr val="0A0A0A"/>
              </a:solidFill>
              <a:latin typeface="Google Sans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07DDC55-059F-1B6C-212E-95E26ECC0184}"/>
              </a:ext>
            </a:extLst>
          </p:cNvPr>
          <p:cNvSpPr/>
          <p:nvPr/>
        </p:nvSpPr>
        <p:spPr>
          <a:xfrm>
            <a:off x="6494586" y="5498122"/>
            <a:ext cx="5331052" cy="6419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600" b="1" i="0" dirty="0">
                <a:solidFill>
                  <a:srgbClr val="0A0A0A"/>
                </a:solidFill>
                <a:effectLst/>
                <a:latin typeface="Google Sans"/>
              </a:rPr>
              <a:t>Supplementary Figure S5 </a:t>
            </a:r>
            <a:r>
              <a:rPr lang="en-US" sz="1600" b="1" dirty="0">
                <a:solidFill>
                  <a:srgbClr val="0A0A0A"/>
                </a:solidFill>
                <a:latin typeface="Google Sans"/>
              </a:rPr>
              <a:t>: High FLI1 immunochemical expression in moderately infiltrating duct carcinoma, (10x)</a:t>
            </a:r>
            <a:endParaRPr lang="en-SG" sz="1600" b="1" dirty="0">
              <a:solidFill>
                <a:srgbClr val="0A0A0A"/>
              </a:solidFill>
              <a:latin typeface="Google Sans"/>
            </a:endParaRPr>
          </a:p>
        </p:txBody>
      </p:sp>
    </p:spTree>
    <p:extLst>
      <p:ext uri="{BB962C8B-B14F-4D97-AF65-F5344CB8AC3E}">
        <p14:creationId xmlns:p14="http://schemas.microsoft.com/office/powerpoint/2010/main" val="11853200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object 5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87569" y="211016"/>
            <a:ext cx="5699271" cy="5180499"/>
          </a:xfrm>
          <a:prstGeom prst="rect">
            <a:avLst/>
          </a:prstGeom>
        </p:spPr>
      </p:pic>
      <p:pic>
        <p:nvPicPr>
          <p:cNvPr id="7" name="object 4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6284504" y="211016"/>
            <a:ext cx="5755095" cy="5180499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96059422-DDA2-D8B2-664F-5B71BE65648D}"/>
              </a:ext>
            </a:extLst>
          </p:cNvPr>
          <p:cNvSpPr/>
          <p:nvPr/>
        </p:nvSpPr>
        <p:spPr>
          <a:xfrm>
            <a:off x="207248" y="5547972"/>
            <a:ext cx="5393001" cy="6419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600" b="1" i="0" dirty="0">
                <a:solidFill>
                  <a:srgbClr val="0A0A0A"/>
                </a:solidFill>
                <a:effectLst/>
                <a:latin typeface="Google Sans"/>
              </a:rPr>
              <a:t>Supplementary Figure S6 </a:t>
            </a:r>
            <a:r>
              <a:rPr lang="en-US" sz="1600" b="1" dirty="0">
                <a:solidFill>
                  <a:srgbClr val="0A0A0A"/>
                </a:solidFill>
                <a:latin typeface="Google Sans"/>
              </a:rPr>
              <a:t>: H&amp;E staining of infiltrating duct carcinoma, Grade III (10x)  </a:t>
            </a:r>
            <a:endParaRPr lang="en-SG" sz="1600" b="1" dirty="0">
              <a:solidFill>
                <a:srgbClr val="0A0A0A"/>
              </a:solidFill>
              <a:latin typeface="Google Sans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DB0E23A-420E-1118-F9E5-4F70E7887466}"/>
              </a:ext>
            </a:extLst>
          </p:cNvPr>
          <p:cNvSpPr/>
          <p:nvPr/>
        </p:nvSpPr>
        <p:spPr>
          <a:xfrm>
            <a:off x="6284504" y="5534619"/>
            <a:ext cx="5331052" cy="9251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600" b="1" i="0" dirty="0">
                <a:solidFill>
                  <a:srgbClr val="0A0A0A"/>
                </a:solidFill>
                <a:effectLst/>
                <a:latin typeface="Google Sans"/>
              </a:rPr>
              <a:t>Supplementary Figure S7 </a:t>
            </a:r>
            <a:r>
              <a:rPr lang="en-US" sz="1600" b="1" dirty="0">
                <a:solidFill>
                  <a:srgbClr val="0A0A0A"/>
                </a:solidFill>
                <a:latin typeface="Google Sans"/>
              </a:rPr>
              <a:t>: High FLI1 immunochemical expression in poorly differentiated infiltrating duct carcinoma, (10x)</a:t>
            </a:r>
            <a:endParaRPr lang="en-SG" sz="1600" b="1" dirty="0">
              <a:solidFill>
                <a:srgbClr val="0A0A0A"/>
              </a:solidFill>
              <a:latin typeface="Google Sans"/>
            </a:endParaRPr>
          </a:p>
        </p:txBody>
      </p:sp>
    </p:spTree>
    <p:extLst>
      <p:ext uri="{BB962C8B-B14F-4D97-AF65-F5344CB8AC3E}">
        <p14:creationId xmlns:p14="http://schemas.microsoft.com/office/powerpoint/2010/main" val="26600428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object 4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413627" y="383932"/>
            <a:ext cx="5570271" cy="5234502"/>
          </a:xfrm>
          <a:prstGeom prst="rect">
            <a:avLst/>
          </a:prstGeom>
        </p:spPr>
      </p:pic>
      <p:pic>
        <p:nvPicPr>
          <p:cNvPr id="7" name="object 5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6328295" y="383930"/>
            <a:ext cx="5669542" cy="5234503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07C3D320-95B9-6EA1-780B-6BF6C85E4412}"/>
              </a:ext>
            </a:extLst>
          </p:cNvPr>
          <p:cNvSpPr/>
          <p:nvPr/>
        </p:nvSpPr>
        <p:spPr>
          <a:xfrm>
            <a:off x="413627" y="5618433"/>
            <a:ext cx="5393001" cy="6419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600" b="1" i="0" dirty="0">
                <a:solidFill>
                  <a:srgbClr val="0A0A0A"/>
                </a:solidFill>
                <a:effectLst/>
                <a:latin typeface="Google Sans"/>
              </a:rPr>
              <a:t>Supplementary Figure S8 </a:t>
            </a:r>
            <a:r>
              <a:rPr lang="en-US" sz="1600" b="1" dirty="0">
                <a:solidFill>
                  <a:srgbClr val="0A0A0A"/>
                </a:solidFill>
                <a:latin typeface="Google Sans"/>
              </a:rPr>
              <a:t>: H&amp;E staining of invasive lobular carcinoma, Grade I (10x)  </a:t>
            </a:r>
            <a:endParaRPr lang="en-SG" sz="1600" b="1" dirty="0">
              <a:solidFill>
                <a:srgbClr val="0A0A0A"/>
              </a:solidFill>
              <a:latin typeface="Google Sans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3524F4B-23E7-6163-2A03-DC072B4AEF15}"/>
              </a:ext>
            </a:extLst>
          </p:cNvPr>
          <p:cNvSpPr/>
          <p:nvPr/>
        </p:nvSpPr>
        <p:spPr>
          <a:xfrm>
            <a:off x="6328295" y="5618433"/>
            <a:ext cx="5331052" cy="6419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600" b="1" i="0" dirty="0">
                <a:solidFill>
                  <a:srgbClr val="0A0A0A"/>
                </a:solidFill>
                <a:effectLst/>
                <a:latin typeface="Google Sans"/>
              </a:rPr>
              <a:t>Supplementary Figure S9 </a:t>
            </a:r>
            <a:r>
              <a:rPr lang="en-US" sz="1600" b="1" dirty="0">
                <a:solidFill>
                  <a:srgbClr val="0A0A0A"/>
                </a:solidFill>
                <a:latin typeface="Google Sans"/>
              </a:rPr>
              <a:t>: Low FLI1 immunochemical expression in invasive lobular carcinoma, Grade I (10x)</a:t>
            </a:r>
            <a:endParaRPr lang="en-SG" sz="1600" b="1" dirty="0">
              <a:solidFill>
                <a:srgbClr val="0A0A0A"/>
              </a:solidFill>
              <a:latin typeface="Google Sans"/>
            </a:endParaRPr>
          </a:p>
        </p:txBody>
      </p:sp>
    </p:spTree>
    <p:extLst>
      <p:ext uri="{BB962C8B-B14F-4D97-AF65-F5344CB8AC3E}">
        <p14:creationId xmlns:p14="http://schemas.microsoft.com/office/powerpoint/2010/main" val="2522021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58</Words>
  <Application>Microsoft Office PowerPoint</Application>
  <PresentationFormat>Widescreen</PresentationFormat>
  <Paragraphs>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Google Sans</vt:lpstr>
      <vt:lpstr>Vrind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 Tasleema Banu (SGH)</dc:creator>
  <cp:lastModifiedBy>Iqbal Jabed</cp:lastModifiedBy>
  <cp:revision>8</cp:revision>
  <dcterms:created xsi:type="dcterms:W3CDTF">2025-09-18T09:17:15Z</dcterms:created>
  <dcterms:modified xsi:type="dcterms:W3CDTF">2025-09-28T02:04:43Z</dcterms:modified>
</cp:coreProperties>
</file>